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  <p:sldId id="259" r:id="rId3"/>
    <p:sldId id="260" r:id="rId4"/>
    <p:sldId id="261" r:id="rId5"/>
    <p:sldId id="262" r:id="rId6"/>
    <p:sldId id="263" r:id="rId7"/>
    <p:sldId id="264" r:id="rId8"/>
    <p:sldId id="265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5" r:id="rId19"/>
    <p:sldId id="286" r:id="rId20"/>
    <p:sldId id="280" r:id="rId21"/>
    <p:sldId id="281" r:id="rId22"/>
    <p:sldId id="282" r:id="rId23"/>
    <p:sldId id="283" r:id="rId24"/>
    <p:sldId id="284" r:id="rId2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10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7445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8988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4323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1419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9226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363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0915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8113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0541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665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9855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E51B0-90FD-47C6-B12A-EB7FDE204DA7}" type="datetimeFigureOut">
              <a:rPr lang="de-DE" smtClean="0"/>
              <a:t>26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020FD-6B50-4B08-B46C-BECE647AF7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3483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4" Type="http://schemas.openxmlformats.org/officeDocument/2006/relationships/image" Target="../media/image9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4" Type="http://schemas.openxmlformats.org/officeDocument/2006/relationships/image" Target="../media/image10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4" Type="http://schemas.openxmlformats.org/officeDocument/2006/relationships/image" Target="../media/image11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4" Type="http://schemas.openxmlformats.org/officeDocument/2006/relationships/image" Target="../media/image12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3.vml"/><Relationship Id="rId4" Type="http://schemas.openxmlformats.org/officeDocument/2006/relationships/image" Target="../media/image13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4.vml"/><Relationship Id="rId4" Type="http://schemas.openxmlformats.org/officeDocument/2006/relationships/image" Target="../media/image14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5.vml"/><Relationship Id="rId4" Type="http://schemas.openxmlformats.org/officeDocument/2006/relationships/image" Target="../media/image15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6.vml"/><Relationship Id="rId4" Type="http://schemas.openxmlformats.org/officeDocument/2006/relationships/image" Target="../media/image16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7.vml"/><Relationship Id="rId4" Type="http://schemas.openxmlformats.org/officeDocument/2006/relationships/image" Target="../media/image17.em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02762" y="2098632"/>
            <a:ext cx="1131844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l Figure 1-17: Plasma levels of  different lipids in nine hospitalized patients at the ICU analyzed at different times in different patients (A–I) using LC-MS/MS as described</a:t>
            </a:r>
          </a:p>
          <a:p>
            <a:r>
              <a:rPr lang="en-US" dirty="0"/>
              <a:t>in material and methods. The normal range of the lipids is visualized as dotted lines, and the range median ± 2-fold upper and lower limit NRL95% as</a:t>
            </a:r>
          </a:p>
          <a:p>
            <a:r>
              <a:rPr lang="en-US" dirty="0"/>
              <a:t>gray background. Graphs of the final data set were created using </a:t>
            </a:r>
            <a:r>
              <a:rPr lang="en-US" dirty="0" err="1"/>
              <a:t>Graphpad</a:t>
            </a:r>
            <a:r>
              <a:rPr lang="en-US" dirty="0"/>
              <a:t> Prism (version 9.5.0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02172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9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2609907"/>
              </p:ext>
            </p:extLst>
          </p:nvPr>
        </p:nvGraphicFramePr>
        <p:xfrm>
          <a:off x="0" y="360000"/>
          <a:ext cx="8091932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73" name="Prism 9" r:id="rId3" imgW="9321393" imgH="7464553" progId="Prism9.Document">
                  <p:embed/>
                </p:oleObj>
              </mc:Choice>
              <mc:Fallback>
                <p:oleObj name="Prism 9" r:id="rId3" imgW="9321393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091932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807827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0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5522855"/>
              </p:ext>
            </p:extLst>
          </p:nvPr>
        </p:nvGraphicFramePr>
        <p:xfrm>
          <a:off x="0" y="359999"/>
          <a:ext cx="8091932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93" name="Prism 9" r:id="rId3" imgW="9319592" imgH="7464553" progId="Prism9.Document">
                  <p:embed/>
                </p:oleObj>
              </mc:Choice>
              <mc:Fallback>
                <p:oleObj name="Prism 9" r:id="rId3" imgW="9319592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59999"/>
                        <a:ext cx="8091932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23876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9375976"/>
              </p:ext>
            </p:extLst>
          </p:nvPr>
        </p:nvGraphicFramePr>
        <p:xfrm>
          <a:off x="0" y="360000"/>
          <a:ext cx="8175471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4" name="Prism 9" r:id="rId3" imgW="9417189" imgH="7464553" progId="Prism9.Document">
                  <p:embed/>
                </p:oleObj>
              </mc:Choice>
              <mc:Fallback>
                <p:oleObj name="Prism 9" r:id="rId3" imgW="9417189" imgH="74645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75471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7713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782173"/>
              </p:ext>
            </p:extLst>
          </p:nvPr>
        </p:nvGraphicFramePr>
        <p:xfrm>
          <a:off x="0" y="360000"/>
          <a:ext cx="8158383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7" name="Prism 9" r:id="rId3" imgW="9397381" imgH="7464553" progId="Prism9.Document">
                  <p:embed/>
                </p:oleObj>
              </mc:Choice>
              <mc:Fallback>
                <p:oleObj name="Prism 9" r:id="rId3" imgW="9397381" imgH="74645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58383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529569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1203584"/>
              </p:ext>
            </p:extLst>
          </p:nvPr>
        </p:nvGraphicFramePr>
        <p:xfrm>
          <a:off x="0" y="360000"/>
          <a:ext cx="8120410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49" name="Prism 9" r:id="rId3" imgW="9353445" imgH="7464553" progId="Prism9.Document">
                  <p:embed/>
                </p:oleObj>
              </mc:Choice>
              <mc:Fallback>
                <p:oleObj name="Prism 9" r:id="rId3" imgW="9353445" imgH="74645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20410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89939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8761890"/>
              </p:ext>
            </p:extLst>
          </p:nvPr>
        </p:nvGraphicFramePr>
        <p:xfrm>
          <a:off x="0" y="360000"/>
          <a:ext cx="8116614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77" name="Prism 9" r:id="rId3" imgW="9350204" imgH="7464553" progId="Prism9.Document">
                  <p:embed/>
                </p:oleObj>
              </mc:Choice>
              <mc:Fallback>
                <p:oleObj name="Prism 9" r:id="rId3" imgW="9350204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16614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4973131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2570865"/>
              </p:ext>
            </p:extLst>
          </p:nvPr>
        </p:nvGraphicFramePr>
        <p:xfrm>
          <a:off x="0" y="360000"/>
          <a:ext cx="8065351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498" name="Prism 9" r:id="rId3" imgW="9289341" imgH="7464553" progId="Prism9.Document">
                  <p:embed/>
                </p:oleObj>
              </mc:Choice>
              <mc:Fallback>
                <p:oleObj name="Prism 9" r:id="rId3" imgW="9289341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065351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1077269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6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9874462"/>
              </p:ext>
            </p:extLst>
          </p:nvPr>
        </p:nvGraphicFramePr>
        <p:xfrm>
          <a:off x="0" y="360000"/>
          <a:ext cx="8116614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21" name="Prism 9" r:id="rId3" imgW="9350204" imgH="7464553" progId="Prism9.Document">
                  <p:embed/>
                </p:oleObj>
              </mc:Choice>
              <mc:Fallback>
                <p:oleObj name="Prism 9" r:id="rId3" imgW="9350204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16614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0174854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7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1758977"/>
              </p:ext>
            </p:extLst>
          </p:nvPr>
        </p:nvGraphicFramePr>
        <p:xfrm>
          <a:off x="0" y="360000"/>
          <a:ext cx="8065351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16" name="Prism 9" r:id="rId3" imgW="9290781" imgH="7464553" progId="Prism9.Document">
                  <p:embed/>
                </p:oleObj>
              </mc:Choice>
              <mc:Fallback>
                <p:oleObj name="Prism 9" r:id="rId3" imgW="9290781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065351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1465507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71339" y="2131998"/>
            <a:ext cx="1138757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l Figure 18-22: Plasma levels of different Lipids after stimulation of venous whole blood</a:t>
            </a:r>
          </a:p>
          <a:p>
            <a:r>
              <a:rPr lang="en-US" dirty="0"/>
              <a:t>with 100 ng/ml LPS for the time periods indicated. Samples were further handled as described in material and methods and plasma levels </a:t>
            </a:r>
            <a:r>
              <a:rPr lang="en-US" dirty="0" smtClean="0"/>
              <a:t>were determined </a:t>
            </a:r>
            <a:r>
              <a:rPr lang="en-US" dirty="0"/>
              <a:t>using LC/MS/MS. Data are median of 10 independent experiments illustrated as box plots with upper and lower whiskers. </a:t>
            </a:r>
            <a:r>
              <a:rPr lang="en-US" dirty="0" smtClean="0"/>
              <a:t>LPS, lipopolysaccharide</a:t>
            </a:r>
            <a:r>
              <a:rPr lang="en-US" dirty="0"/>
              <a:t>. Levels of significance of control versus sample treated with LPS: *p&lt; 0.05; **p&lt;0.01. Graphs and statistics of </a:t>
            </a:r>
            <a:r>
              <a:rPr lang="en-US" dirty="0" smtClean="0"/>
              <a:t>the final </a:t>
            </a:r>
            <a:r>
              <a:rPr lang="en-US" dirty="0"/>
              <a:t>data set were created using R software (version 3.5.1, open-source software 2018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22765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2066498"/>
              </p:ext>
            </p:extLst>
          </p:nvPr>
        </p:nvGraphicFramePr>
        <p:xfrm>
          <a:off x="0" y="360000"/>
          <a:ext cx="8116614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7" name="Prism 9" r:id="rId3" imgW="9350204" imgH="7464553" progId="Prism9.Document">
                  <p:embed/>
                </p:oleObj>
              </mc:Choice>
              <mc:Fallback>
                <p:oleObj name="Prism 9" r:id="rId3" imgW="9350204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16614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4970193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nhaltsplatzhalter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0146" y="3755303"/>
            <a:ext cx="2286000" cy="2286000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627" y="3752569"/>
            <a:ext cx="2286000" cy="2286000"/>
          </a:xfrm>
          <a:prstGeom prst="rect">
            <a:avLst/>
          </a:prstGeom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86" y="7817"/>
            <a:ext cx="8229600" cy="562074"/>
          </a:xfrm>
        </p:spPr>
        <p:txBody>
          <a:bodyPr>
            <a:normAutofit/>
          </a:bodyPr>
          <a:lstStyle/>
          <a:p>
            <a:pPr algn="l"/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18</a:t>
            </a:r>
            <a:endParaRPr lang="de-DE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0146" y="1358944"/>
            <a:ext cx="2286000" cy="2286000"/>
          </a:xfrm>
          <a:prstGeom prst="rect">
            <a:avLst/>
          </a:prstGeom>
        </p:spPr>
      </p:pic>
      <p:sp>
        <p:nvSpPr>
          <p:cNvPr id="48" name="Textfeld 47"/>
          <p:cNvSpPr txBox="1"/>
          <p:nvPr/>
        </p:nvSpPr>
        <p:spPr>
          <a:xfrm>
            <a:off x="521987" y="1063856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A                                                      B                                                    C</a:t>
            </a:r>
          </a:p>
        </p:txBody>
      </p:sp>
      <p:pic>
        <p:nvPicPr>
          <p:cNvPr id="19" name="Inhaltsplatzhalter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627" y="1373967"/>
            <a:ext cx="2286000" cy="2286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8223" y="1358944"/>
            <a:ext cx="2286000" cy="2286000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8223" y="3778465"/>
            <a:ext cx="2286000" cy="2286000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1515024" y="1848191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2388982" y="2062676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1939657" y="2062676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1955466" y="4365460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2387514" y="4088192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4979627" y="4016184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549222" y="4438940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7572090" y="4664256"/>
            <a:ext cx="422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521987" y="3601049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D                                                      E                                                    F</a:t>
            </a:r>
          </a:p>
        </p:txBody>
      </p:sp>
    </p:spTree>
    <p:extLst>
      <p:ext uri="{BB962C8B-B14F-4D97-AF65-F5344CB8AC3E}">
        <p14:creationId xmlns:p14="http://schemas.microsoft.com/office/powerpoint/2010/main" val="36166915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nhaltsplatzhalter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8209" y="3360448"/>
            <a:ext cx="2286000" cy="2286000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252" y="3357714"/>
            <a:ext cx="2286000" cy="2286000"/>
          </a:xfrm>
          <a:prstGeom prst="rect">
            <a:avLst/>
          </a:prstGeom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3983"/>
            <a:ext cx="8229600" cy="562074"/>
          </a:xfrm>
        </p:spPr>
        <p:txBody>
          <a:bodyPr>
            <a:normAutofit/>
          </a:bodyPr>
          <a:lstStyle/>
          <a:p>
            <a:pPr algn="l"/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19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8209" y="964089"/>
            <a:ext cx="2286000" cy="2286000"/>
          </a:xfrm>
          <a:prstGeom prst="rect">
            <a:avLst/>
          </a:prstGeom>
        </p:spPr>
      </p:pic>
      <p:pic>
        <p:nvPicPr>
          <p:cNvPr id="19" name="Inhaltsplatzhalter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641" y="979112"/>
            <a:ext cx="2286000" cy="2286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542" y="964089"/>
            <a:ext cx="2286000" cy="2286000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542" y="3383610"/>
            <a:ext cx="2286000" cy="2286000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6761674" y="4131382"/>
            <a:ext cx="4632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58306" y="669001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A                                                      B                                                    C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158306" y="3206194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D                                                      E                                                    F</a:t>
            </a:r>
          </a:p>
        </p:txBody>
      </p:sp>
    </p:spTree>
    <p:extLst>
      <p:ext uri="{BB962C8B-B14F-4D97-AF65-F5344CB8AC3E}">
        <p14:creationId xmlns:p14="http://schemas.microsoft.com/office/powerpoint/2010/main" val="27367904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nhaltsplatzhalter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6254" y="3370839"/>
            <a:ext cx="2286000" cy="2286000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297" y="3368105"/>
            <a:ext cx="2286000" cy="2286000"/>
          </a:xfrm>
          <a:prstGeom prst="rect">
            <a:avLst/>
          </a:prstGeom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0" y="-2174"/>
            <a:ext cx="8229600" cy="562074"/>
          </a:xfrm>
        </p:spPr>
        <p:txBody>
          <a:bodyPr>
            <a:normAutofit/>
          </a:bodyPr>
          <a:lstStyle/>
          <a:p>
            <a:pPr algn="l"/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20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6254" y="974480"/>
            <a:ext cx="2286000" cy="2286000"/>
          </a:xfrm>
          <a:prstGeom prst="rect">
            <a:avLst/>
          </a:prstGeom>
        </p:spPr>
      </p:pic>
      <p:pic>
        <p:nvPicPr>
          <p:cNvPr id="19" name="Inhaltsplatzhalter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686" y="989503"/>
            <a:ext cx="2286000" cy="2286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2587" y="974480"/>
            <a:ext cx="2286000" cy="2286000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2587" y="3394001"/>
            <a:ext cx="2286000" cy="2286000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4204126" y="1452794"/>
            <a:ext cx="422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24" name="Textfeld 23"/>
          <p:cNvSpPr txBox="1"/>
          <p:nvPr/>
        </p:nvSpPr>
        <p:spPr>
          <a:xfrm flipH="1">
            <a:off x="1595402" y="1255456"/>
            <a:ext cx="376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630573" y="1750220"/>
            <a:ext cx="422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6691110" y="1894236"/>
            <a:ext cx="422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1971878" y="4054476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1539830" y="3991760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4626322" y="4054476"/>
            <a:ext cx="422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4191453" y="4486524"/>
            <a:ext cx="422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3781930" y="4486524"/>
            <a:ext cx="422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106351" y="679392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A                                                      B                                                    C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106351" y="3216585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D                                                      E                                                    F</a:t>
            </a:r>
          </a:p>
        </p:txBody>
      </p:sp>
    </p:spTree>
    <p:extLst>
      <p:ext uri="{BB962C8B-B14F-4D97-AF65-F5344CB8AC3E}">
        <p14:creationId xmlns:p14="http://schemas.microsoft.com/office/powerpoint/2010/main" val="3986622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nhaltsplatzhalter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5472" y="3318884"/>
            <a:ext cx="2286000" cy="2286000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515" y="3316150"/>
            <a:ext cx="2286000" cy="2286000"/>
          </a:xfrm>
          <a:prstGeom prst="rect">
            <a:avLst/>
          </a:prstGeom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-11331" y="-9927"/>
            <a:ext cx="8229600" cy="562074"/>
          </a:xfrm>
        </p:spPr>
        <p:txBody>
          <a:bodyPr>
            <a:normAutofit/>
          </a:bodyPr>
          <a:lstStyle/>
          <a:p>
            <a:pPr algn="l"/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/>
              <a:t> 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21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5472" y="922525"/>
            <a:ext cx="2286000" cy="2286000"/>
          </a:xfrm>
          <a:prstGeom prst="rect">
            <a:avLst/>
          </a:prstGeom>
        </p:spPr>
      </p:pic>
      <p:pic>
        <p:nvPicPr>
          <p:cNvPr id="19" name="Inhaltsplatzhalter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904" y="937548"/>
            <a:ext cx="2286000" cy="2286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1805" y="922525"/>
            <a:ext cx="2286000" cy="2286000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1805" y="3342046"/>
            <a:ext cx="2286000" cy="2286000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1944919" y="1275509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1519048" y="1531820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552582" y="1372107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4111336" y="1460175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1953732" y="3739340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1544209" y="3802229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4543384" y="4146537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4105722" y="3786497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6624136" y="4089818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7117336" y="4118796"/>
            <a:ext cx="340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2768157" y="3305688"/>
            <a:ext cx="321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E                                                    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85569" y="627437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A                                                      B                                                    C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85569" y="3164630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  D                                                      E                                                    F</a:t>
            </a:r>
          </a:p>
        </p:txBody>
      </p:sp>
    </p:spTree>
    <p:extLst>
      <p:ext uri="{BB962C8B-B14F-4D97-AF65-F5344CB8AC3E}">
        <p14:creationId xmlns:p14="http://schemas.microsoft.com/office/powerpoint/2010/main" val="24221289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-36492" y="10389"/>
            <a:ext cx="8229600" cy="562074"/>
          </a:xfrm>
        </p:spPr>
        <p:txBody>
          <a:bodyPr>
            <a:normAutofit/>
          </a:bodyPr>
          <a:lstStyle/>
          <a:p>
            <a:pPr algn="l"/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Figure 22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199871" y="772886"/>
            <a:ext cx="7186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A                                                </a:t>
            </a:r>
            <a:r>
              <a:rPr lang="de-DE" sz="1600" b="1" dirty="0" smtClean="0"/>
              <a:t>    B                                                    </a:t>
            </a:r>
            <a:endParaRPr lang="de-DE" sz="1600" b="1" dirty="0"/>
          </a:p>
        </p:txBody>
      </p:sp>
      <p:pic>
        <p:nvPicPr>
          <p:cNvPr id="19" name="Inhaltsplatzhalter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871" y="1051848"/>
            <a:ext cx="2286000" cy="2286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8772" y="1036825"/>
            <a:ext cx="2286000" cy="2286000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4522744" y="1341778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1911275" y="2028589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088303" y="1317801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1496015" y="1956581"/>
            <a:ext cx="5745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440780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1988759"/>
              </p:ext>
            </p:extLst>
          </p:nvPr>
        </p:nvGraphicFramePr>
        <p:xfrm>
          <a:off x="0" y="360000"/>
          <a:ext cx="8065351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4" name="Prism 9" r:id="rId3" imgW="9290781" imgH="7464553" progId="Prism9.Document">
                  <p:embed/>
                </p:oleObj>
              </mc:Choice>
              <mc:Fallback>
                <p:oleObj name="Prism 9" r:id="rId3" imgW="9290781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065351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83546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9676505"/>
              </p:ext>
            </p:extLst>
          </p:nvPr>
        </p:nvGraphicFramePr>
        <p:xfrm>
          <a:off x="0" y="360000"/>
          <a:ext cx="8120410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7" name="Prism 9" r:id="rId3" imgW="9353445" imgH="7464553" progId="Prism9.Document">
                  <p:embed/>
                </p:oleObj>
              </mc:Choice>
              <mc:Fallback>
                <p:oleObj name="Prism 9" r:id="rId3" imgW="9353445" imgH="74645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20410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69011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3610170"/>
              </p:ext>
            </p:extLst>
          </p:nvPr>
        </p:nvGraphicFramePr>
        <p:xfrm>
          <a:off x="0" y="360000"/>
          <a:ext cx="8122310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11" name="Prism 9" r:id="rId3" imgW="9354885" imgH="7464553" progId="Prism9.Document">
                  <p:embed/>
                </p:oleObj>
              </mc:Choice>
              <mc:Fallback>
                <p:oleObj name="Prism 9" r:id="rId3" imgW="9354885" imgH="74645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22310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35293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6506172"/>
              </p:ext>
            </p:extLst>
          </p:nvPr>
        </p:nvGraphicFramePr>
        <p:xfrm>
          <a:off x="0" y="360000"/>
          <a:ext cx="8156485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34" name="Prism 9" r:id="rId3" imgW="9394500" imgH="7464553" progId="Prism9.Document">
                  <p:embed/>
                </p:oleObj>
              </mc:Choice>
              <mc:Fallback>
                <p:oleObj name="Prism 9" r:id="rId3" imgW="9394500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56485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099459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054611"/>
              </p:ext>
            </p:extLst>
          </p:nvPr>
        </p:nvGraphicFramePr>
        <p:xfrm>
          <a:off x="0" y="360000"/>
          <a:ext cx="8065351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59" name="Prism 9" r:id="rId3" imgW="9292222" imgH="7464553" progId="Prism9.Document">
                  <p:embed/>
                </p:oleObj>
              </mc:Choice>
              <mc:Fallback>
                <p:oleObj name="Prism 9" r:id="rId3" imgW="9292222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065351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731268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6552896"/>
              </p:ext>
            </p:extLst>
          </p:nvPr>
        </p:nvGraphicFramePr>
        <p:xfrm>
          <a:off x="0" y="360000"/>
          <a:ext cx="8120410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1" name="Prism 9" r:id="rId3" imgW="9353445" imgH="7464553" progId="Prism9.Document">
                  <p:embed/>
                </p:oleObj>
              </mc:Choice>
              <mc:Fallback>
                <p:oleObj name="Prism 9" r:id="rId3" imgW="9353445" imgH="74645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120410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7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61241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0" y="0"/>
            <a:ext cx="3325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8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1868359"/>
              </p:ext>
            </p:extLst>
          </p:nvPr>
        </p:nvGraphicFramePr>
        <p:xfrm>
          <a:off x="0" y="360000"/>
          <a:ext cx="8091932" cy="64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49" name="Prism 9" r:id="rId3" imgW="9321393" imgH="7464553" progId="Prism9.Document">
                  <p:embed/>
                </p:oleObj>
              </mc:Choice>
              <mc:Fallback>
                <p:oleObj name="Prism 9" r:id="rId3" imgW="9321393" imgH="7464553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60000"/>
                        <a:ext cx="8091932" cy="64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43606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2</Words>
  <Application>Microsoft Office PowerPoint</Application>
  <PresentationFormat>Widescreen</PresentationFormat>
  <Paragraphs>69</Paragraphs>
  <Slides>2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9" baseType="lpstr">
      <vt:lpstr>Arial</vt:lpstr>
      <vt:lpstr>Calibri</vt:lpstr>
      <vt:lpstr>Calibri Light</vt:lpstr>
      <vt:lpstr>Offic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l Figure 18</vt:lpstr>
      <vt:lpstr>Supplemental Figure 19</vt:lpstr>
      <vt:lpstr>Supplemental Figure 20</vt:lpstr>
      <vt:lpstr>Supplemental Figure 21</vt:lpstr>
      <vt:lpstr>Supplemental Figure 22</vt:lpstr>
    </vt:vector>
  </TitlesOfParts>
  <Company>Paul-Ehrlich-Instit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th, Verena</dc:creator>
  <cp:lastModifiedBy>Maier, Thorsten Jürgen</cp:lastModifiedBy>
  <cp:revision>52</cp:revision>
  <dcterms:created xsi:type="dcterms:W3CDTF">2024-05-13T09:55:57Z</dcterms:created>
  <dcterms:modified xsi:type="dcterms:W3CDTF">2024-06-26T08:35:06Z</dcterms:modified>
</cp:coreProperties>
</file>